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9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2"/>
    <p:restoredTop sz="96197"/>
  </p:normalViewPr>
  <p:slideViewPr>
    <p:cSldViewPr snapToGrid="0" showGuides="1">
      <p:cViewPr varScale="1">
        <p:scale>
          <a:sx n="80" d="100"/>
          <a:sy n="80" d="100"/>
        </p:scale>
        <p:origin x="1784" y="21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E100-15F6-AD4C-809E-204DBE3EAABD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AC37F-10FB-7742-9C1F-F9B21553FF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41E772-9E0B-9E40-B3C3-9E49D4959BE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18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3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856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4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1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9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7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2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05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D59482-7549-5048-BAE2-B7798FA67DD7}"/>
              </a:ext>
            </a:extLst>
          </p:cNvPr>
          <p:cNvSpPr txBox="1"/>
          <p:nvPr/>
        </p:nvSpPr>
        <p:spPr>
          <a:xfrm>
            <a:off x="6513803" y="1818882"/>
            <a:ext cx="527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,00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A2328FC-95E4-0540-8D75-94736608D9A2}"/>
              </a:ext>
            </a:extLst>
          </p:cNvPr>
          <p:cNvSpPr txBox="1"/>
          <p:nvPr/>
        </p:nvSpPr>
        <p:spPr>
          <a:xfrm>
            <a:off x="5936027" y="1818021"/>
            <a:ext cx="575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,00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315C0EB-3C91-544D-8DEB-0CE6A3ADBF13}"/>
              </a:ext>
            </a:extLst>
          </p:cNvPr>
          <p:cNvSpPr txBox="1"/>
          <p:nvPr/>
        </p:nvSpPr>
        <p:spPr>
          <a:xfrm>
            <a:off x="7198935" y="1818021"/>
            <a:ext cx="306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34C882D-201A-054A-BD2C-E6E91EC5F36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5389" r="30356" b="24859"/>
          <a:stretch/>
        </p:blipFill>
        <p:spPr>
          <a:xfrm rot="16200000">
            <a:off x="6636567" y="1233773"/>
            <a:ext cx="98054" cy="157864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EC18115-FD84-1A48-A2D5-605DE4F28828}"/>
              </a:ext>
            </a:extLst>
          </p:cNvPr>
          <p:cNvSpPr txBox="1"/>
          <p:nvPr/>
        </p:nvSpPr>
        <p:spPr>
          <a:xfrm>
            <a:off x="0" y="614638"/>
            <a:ext cx="644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 µg WT #1-5</a:t>
            </a:r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73D83F13-AA5F-C647-8883-5563AC40F3CE}"/>
              </a:ext>
            </a:extLst>
          </p:cNvPr>
          <p:cNvSpPr/>
          <p:nvPr/>
        </p:nvSpPr>
        <p:spPr>
          <a:xfrm rot="10800000">
            <a:off x="500956" y="519504"/>
            <a:ext cx="104816" cy="535772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D8528B82-4556-0744-B58F-1CBCB5655BB9}"/>
              </a:ext>
            </a:extLst>
          </p:cNvPr>
          <p:cNvSpPr/>
          <p:nvPr/>
        </p:nvSpPr>
        <p:spPr>
          <a:xfrm rot="10800000">
            <a:off x="514332" y="1059832"/>
            <a:ext cx="91440" cy="535773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0C56297-DA12-3141-9120-5BDC0D5A1608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605772" y="511552"/>
            <a:ext cx="6858000" cy="109540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C0C0E8D-67C2-474A-97FA-2F100BA26BF0}"/>
              </a:ext>
            </a:extLst>
          </p:cNvPr>
          <p:cNvSpPr txBox="1"/>
          <p:nvPr/>
        </p:nvSpPr>
        <p:spPr>
          <a:xfrm>
            <a:off x="0" y="1154465"/>
            <a:ext cx="649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 µg PF #1-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52C2A7-BA91-BF43-B23A-A5E0A1622E24}"/>
              </a:ext>
            </a:extLst>
          </p:cNvPr>
          <p:cNvSpPr txBox="1"/>
          <p:nvPr/>
        </p:nvSpPr>
        <p:spPr>
          <a:xfrm>
            <a:off x="275182" y="2424785"/>
            <a:ext cx="722203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3. Peptide array mapping of linear epitopes associated with the vaccine induced humoral response in vaccinated animal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rray comprised 120 peptides spanning the length of the 491 aa LASV GPC. Each 15-mer peptide overlaps the next by 11 amino acids. Stable signal peptide (SSP) in peach, N-terminal domain (NTD) of GP1 in tangerine, GP1 in yellow, fusion loop in violet, HR-1 in pink, T-loop in light blue, HR-2 in mint green, TM in orange, cytoplasmic tail in cyan. Each sample was run in triplicate. 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2919B60-3409-5749-B5DF-C3C29A58605C}"/>
              </a:ext>
            </a:extLst>
          </p:cNvPr>
          <p:cNvCxnSpPr>
            <a:cxnSpLocks/>
          </p:cNvCxnSpPr>
          <p:nvPr/>
        </p:nvCxnSpPr>
        <p:spPr>
          <a:xfrm flipV="1">
            <a:off x="4218419" y="1824472"/>
            <a:ext cx="0" cy="16448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1411B4B-8645-C147-861D-475946F68404}"/>
              </a:ext>
            </a:extLst>
          </p:cNvPr>
          <p:cNvSpPr txBox="1"/>
          <p:nvPr/>
        </p:nvSpPr>
        <p:spPr>
          <a:xfrm>
            <a:off x="3801719" y="1933925"/>
            <a:ext cx="823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leavage site (259-260)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2AC4E18E-D98E-8246-AF1E-362A4A418E8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/>
          <a:stretch/>
        </p:blipFill>
        <p:spPr>
          <a:xfrm>
            <a:off x="605772" y="1607760"/>
            <a:ext cx="6858000" cy="21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806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2</TotalTime>
  <Words>123</Words>
  <Application>Microsoft Macintosh PowerPoint</Application>
  <PresentationFormat>Custom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3</cp:revision>
  <dcterms:created xsi:type="dcterms:W3CDTF">2023-08-11T15:29:34Z</dcterms:created>
  <dcterms:modified xsi:type="dcterms:W3CDTF">2023-08-11T16:37:33Z</dcterms:modified>
</cp:coreProperties>
</file>